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68" r:id="rId2"/>
    <p:sldId id="272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7853C-536D-4A76-A0AE-DD22124D55A5}" styleName="主题样式 1 - 强调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3C2FFA5D-87B4-456A-9821-1D502468CF0F}" styleName="主题样式 1 - 强调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77816" autoAdjust="0"/>
  </p:normalViewPr>
  <p:slideViewPr>
    <p:cSldViewPr snapToGrid="0">
      <p:cViewPr varScale="1">
        <p:scale>
          <a:sx n="47" d="100"/>
          <a:sy n="47" d="100"/>
        </p:scale>
        <p:origin x="2196" y="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D5EB5D-5045-4839-8430-874ABD387C00}" type="datetimeFigureOut">
              <a:rPr kumimoji="1" lang="ja-JP" altLang="en-US" smtClean="0"/>
              <a:t>2022/10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17BD7D-C9AA-45A3-92D8-F9DE35E2E2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36573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r>
              <a:rPr kumimoji="1" lang="en-US" altLang="ja-JP" sz="1800" b="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ja-JP" altLang="ja-JP" sz="180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ja-JP" sz="180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ow chart of the selection process for studies.</a:t>
            </a:r>
            <a:endParaRPr kumimoji="1" lang="ja-JP" altLang="en-US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17BD7D-C9AA-45A3-92D8-F9DE35E2E25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89337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r>
              <a:rPr kumimoji="1" lang="en-US" altLang="ja-JP" sz="1800" b="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ja-JP" altLang="ja-JP" sz="180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ja-JP" sz="180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ow chart of the selection process for studies.</a:t>
            </a:r>
            <a:endParaRPr kumimoji="1" lang="ja-JP" altLang="en-US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C17BD7D-C9AA-45A3-92D8-F9DE35E2E254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489337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4D3CB-E411-4154-BFB1-2139EAC67FEA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C630F-299B-4B64-B24F-A5DDA606EE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21270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4D3CB-E411-4154-BFB1-2139EAC67FEA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C630F-299B-4B64-B24F-A5DDA606EE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63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4D3CB-E411-4154-BFB1-2139EAC67FEA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C630F-299B-4B64-B24F-A5DDA606EE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373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4D3CB-E411-4154-BFB1-2139EAC67FEA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C630F-299B-4B64-B24F-A5DDA606EE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9117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4D3CB-E411-4154-BFB1-2139EAC67FEA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C630F-299B-4B64-B24F-A5DDA606EE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90333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4D3CB-E411-4154-BFB1-2139EAC67FEA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C630F-299B-4B64-B24F-A5DDA606EE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3674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4D3CB-E411-4154-BFB1-2139EAC67FEA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C630F-299B-4B64-B24F-A5DDA606EE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1427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4D3CB-E411-4154-BFB1-2139EAC67FEA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C630F-299B-4B64-B24F-A5DDA606EE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9199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4D3CB-E411-4154-BFB1-2139EAC67FEA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C630F-299B-4B64-B24F-A5DDA606EE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5869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4D3CB-E411-4154-BFB1-2139EAC67FEA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C630F-299B-4B64-B24F-A5DDA606EE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0353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4D3CB-E411-4154-BFB1-2139EAC67FEA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C630F-299B-4B64-B24F-A5DDA606EE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7609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C4D3CB-E411-4154-BFB1-2139EAC67FEA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FC630F-299B-4B64-B24F-A5DDA606EE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4191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2" y="-2"/>
            <a:ext cx="1306284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799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kumimoji="1" lang="ja-JP" altLang="en-US" sz="1799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25053EC0-4014-467D-12AF-51DEFD1B9BF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8117932"/>
              </p:ext>
            </p:extLst>
          </p:nvPr>
        </p:nvGraphicFramePr>
        <p:xfrm>
          <a:off x="308466" y="2146596"/>
          <a:ext cx="6273666" cy="5511128"/>
        </p:xfrm>
        <a:graphic>
          <a:graphicData uri="http://schemas.openxmlformats.org/drawingml/2006/table">
            <a:tbl>
              <a:tblPr/>
              <a:tblGrid>
                <a:gridCol w="1485666">
                  <a:extLst>
                    <a:ext uri="{9D8B030D-6E8A-4147-A177-3AD203B41FA5}">
                      <a16:colId xmlns:a16="http://schemas.microsoft.com/office/drawing/2014/main" val="164766289"/>
                    </a:ext>
                  </a:extLst>
                </a:gridCol>
                <a:gridCol w="684000">
                  <a:extLst>
                    <a:ext uri="{9D8B030D-6E8A-4147-A177-3AD203B41FA5}">
                      <a16:colId xmlns:a16="http://schemas.microsoft.com/office/drawing/2014/main" val="459033327"/>
                    </a:ext>
                  </a:extLst>
                </a:gridCol>
                <a:gridCol w="684000">
                  <a:extLst>
                    <a:ext uri="{9D8B030D-6E8A-4147-A177-3AD203B41FA5}">
                      <a16:colId xmlns:a16="http://schemas.microsoft.com/office/drawing/2014/main" val="752813173"/>
                    </a:ext>
                  </a:extLst>
                </a:gridCol>
                <a:gridCol w="684000">
                  <a:extLst>
                    <a:ext uri="{9D8B030D-6E8A-4147-A177-3AD203B41FA5}">
                      <a16:colId xmlns:a16="http://schemas.microsoft.com/office/drawing/2014/main" val="3582883301"/>
                    </a:ext>
                  </a:extLst>
                </a:gridCol>
                <a:gridCol w="684000">
                  <a:extLst>
                    <a:ext uri="{9D8B030D-6E8A-4147-A177-3AD203B41FA5}">
                      <a16:colId xmlns:a16="http://schemas.microsoft.com/office/drawing/2014/main" val="3511952925"/>
                    </a:ext>
                  </a:extLst>
                </a:gridCol>
                <a:gridCol w="684000">
                  <a:extLst>
                    <a:ext uri="{9D8B030D-6E8A-4147-A177-3AD203B41FA5}">
                      <a16:colId xmlns:a16="http://schemas.microsoft.com/office/drawing/2014/main" val="3958671777"/>
                    </a:ext>
                  </a:extLst>
                </a:gridCol>
                <a:gridCol w="684000">
                  <a:extLst>
                    <a:ext uri="{9D8B030D-6E8A-4147-A177-3AD203B41FA5}">
                      <a16:colId xmlns:a16="http://schemas.microsoft.com/office/drawing/2014/main" val="746845083"/>
                    </a:ext>
                  </a:extLst>
                </a:gridCol>
                <a:gridCol w="684000">
                  <a:extLst>
                    <a:ext uri="{9D8B030D-6E8A-4147-A177-3AD203B41FA5}">
                      <a16:colId xmlns:a16="http://schemas.microsoft.com/office/drawing/2014/main" val="549659317"/>
                    </a:ext>
                  </a:extLst>
                </a:gridCol>
              </a:tblGrid>
              <a:tr h="44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hoi 2018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3210881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. Crass 2019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7931641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ong 2014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0301419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ujii 2014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3359019"/>
                  </a:ext>
                </a:extLst>
              </a:tr>
              <a:tr h="3170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iunio-Zorkin 2019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2342478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Hiraki 2012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0621942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Hirano 2014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11249583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Han 2022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3128433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Hsu 2022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805128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Jones 2014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2807758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Kim 2019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719145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Kawasuji 2021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5951072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Komatsu 2022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9024397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ima 2019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6913595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in 2006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8464479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raza 2015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0693144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ray 2022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3980963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lachouras 2006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73441144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Qin 2021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4519675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abon 2018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5160081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ato 2020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7559330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akahashi 2010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7339283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hirot 2021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8787146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Wu 2006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2436258"/>
                  </a:ext>
                </a:extLst>
              </a:tr>
              <a:tr h="199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Wu 2022</a:t>
                      </a: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58" marR="3058" marT="30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4645351"/>
                  </a:ext>
                </a:extLst>
              </a:tr>
            </a:tbl>
          </a:graphicData>
        </a:graphic>
      </p:graphicFrame>
      <p:graphicFrame>
        <p:nvGraphicFramePr>
          <p:cNvPr id="7" name="表格 6">
            <a:extLst>
              <a:ext uri="{FF2B5EF4-FFF2-40B4-BE49-F238E27FC236}">
                <a16:creationId xmlns:a16="http://schemas.microsoft.com/office/drawing/2014/main" id="{E1A582C9-3BF0-9C31-FF1A-70D1D788A5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56986267"/>
              </p:ext>
            </p:extLst>
          </p:nvPr>
        </p:nvGraphicFramePr>
        <p:xfrm>
          <a:off x="1791620" y="7862826"/>
          <a:ext cx="641444" cy="1120141"/>
        </p:xfrm>
        <a:graphic>
          <a:graphicData uri="http://schemas.openxmlformats.org/drawingml/2006/table">
            <a:tbl>
              <a:tblPr/>
              <a:tblGrid>
                <a:gridCol w="641444">
                  <a:extLst>
                    <a:ext uri="{9D8B030D-6E8A-4147-A177-3AD203B41FA5}">
                      <a16:colId xmlns:a16="http://schemas.microsoft.com/office/drawing/2014/main" val="3110169190"/>
                    </a:ext>
                  </a:extLst>
                </a:gridCol>
              </a:tblGrid>
              <a:tr h="277674"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7389325"/>
                  </a:ext>
                </a:extLst>
              </a:tr>
              <a:tr h="287119"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2588837"/>
                  </a:ext>
                </a:extLst>
              </a:tr>
              <a:tr h="277674"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6588592"/>
                  </a:ext>
                </a:extLst>
              </a:tr>
              <a:tr h="277674"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2972199"/>
                  </a:ext>
                </a:extLst>
              </a:tr>
            </a:tbl>
          </a:graphicData>
        </a:graphic>
      </p:graphicFrame>
      <p:sp>
        <p:nvSpPr>
          <p:cNvPr id="9" name="文本框 8">
            <a:extLst>
              <a:ext uri="{FF2B5EF4-FFF2-40B4-BE49-F238E27FC236}">
                <a16:creationId xmlns:a16="http://schemas.microsoft.com/office/drawing/2014/main" id="{08311D8B-1E14-211E-7970-56DA90651DFA}"/>
              </a:ext>
            </a:extLst>
          </p:cNvPr>
          <p:cNvSpPr txBox="1"/>
          <p:nvPr/>
        </p:nvSpPr>
        <p:spPr>
          <a:xfrm rot="16200000">
            <a:off x="1364062" y="1259418"/>
            <a:ext cx="14670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founding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0737A52-055D-A055-A66E-5236592D7697}"/>
              </a:ext>
            </a:extLst>
          </p:cNvPr>
          <p:cNvSpPr txBox="1"/>
          <p:nvPr/>
        </p:nvSpPr>
        <p:spPr>
          <a:xfrm rot="16200000">
            <a:off x="2159233" y="1398879"/>
            <a:ext cx="11881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ection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339FA7D-EB44-0164-8B33-CB4CC0D11599}"/>
              </a:ext>
            </a:extLst>
          </p:cNvPr>
          <p:cNvSpPr txBox="1"/>
          <p:nvPr/>
        </p:nvSpPr>
        <p:spPr>
          <a:xfrm rot="16200000">
            <a:off x="2747031" y="1294684"/>
            <a:ext cx="13965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vention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1AB4B22-9EB5-85EE-C553-636AFDA9147B}"/>
              </a:ext>
            </a:extLst>
          </p:cNvPr>
          <p:cNvSpPr txBox="1"/>
          <p:nvPr/>
        </p:nvSpPr>
        <p:spPr>
          <a:xfrm rot="16200000">
            <a:off x="3089052" y="839059"/>
            <a:ext cx="209544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viation from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nded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vention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EAF6842-9525-1B6A-5DEB-E47F8483AA2B}"/>
              </a:ext>
            </a:extLst>
          </p:cNvPr>
          <p:cNvSpPr txBox="1"/>
          <p:nvPr/>
        </p:nvSpPr>
        <p:spPr>
          <a:xfrm rot="16200000">
            <a:off x="4130830" y="1270639"/>
            <a:ext cx="14446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ssing data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F3E19D0-12FF-5808-3264-997C546CBF44}"/>
              </a:ext>
            </a:extLst>
          </p:cNvPr>
          <p:cNvSpPr txBox="1"/>
          <p:nvPr/>
        </p:nvSpPr>
        <p:spPr>
          <a:xfrm rot="16200000">
            <a:off x="4865582" y="1206199"/>
            <a:ext cx="13580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surement of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utcome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6857D55-4AC0-3EE4-4EBC-76E50BC8E70E}"/>
              </a:ext>
            </a:extLst>
          </p:cNvPr>
          <p:cNvSpPr txBox="1"/>
          <p:nvPr/>
        </p:nvSpPr>
        <p:spPr>
          <a:xfrm rot="16200000">
            <a:off x="5617165" y="1374033"/>
            <a:ext cx="1237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orting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D62476F-53DC-460A-7BBE-9E75D6D34197}"/>
              </a:ext>
            </a:extLst>
          </p:cNvPr>
          <p:cNvSpPr txBox="1"/>
          <p:nvPr/>
        </p:nvSpPr>
        <p:spPr>
          <a:xfrm>
            <a:off x="2509809" y="7826675"/>
            <a:ext cx="1626965" cy="1192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200"/>
              </a:lnSpc>
            </a:pP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</a:p>
          <a:p>
            <a:pPr>
              <a:lnSpc>
                <a:spcPts val="2200"/>
              </a:lnSpc>
            </a:pP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rate</a:t>
            </a:r>
          </a:p>
          <a:p>
            <a:pPr>
              <a:lnSpc>
                <a:spcPts val="2200"/>
              </a:lnSpc>
            </a:pP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</a:p>
          <a:p>
            <a:pPr>
              <a:lnSpc>
                <a:spcPts val="2200"/>
              </a:lnSpc>
            </a:pP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informatio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650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" y="-2"/>
            <a:ext cx="1405717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799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igure S2</a:t>
            </a:r>
            <a:endParaRPr kumimoji="1" lang="ja-JP" altLang="en-US" sz="1799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5B541081-994B-C095-D77E-A3518477EF6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5824721"/>
              </p:ext>
            </p:extLst>
          </p:nvPr>
        </p:nvGraphicFramePr>
        <p:xfrm>
          <a:off x="277939" y="2052677"/>
          <a:ext cx="6302121" cy="5760720"/>
        </p:xfrm>
        <a:graphic>
          <a:graphicData uri="http://schemas.openxmlformats.org/drawingml/2006/table">
            <a:tbl>
              <a:tblPr/>
              <a:tblGrid>
                <a:gridCol w="1312451">
                  <a:extLst>
                    <a:ext uri="{9D8B030D-6E8A-4147-A177-3AD203B41FA5}">
                      <a16:colId xmlns:a16="http://schemas.microsoft.com/office/drawing/2014/main" val="1627508870"/>
                    </a:ext>
                  </a:extLst>
                </a:gridCol>
                <a:gridCol w="712810">
                  <a:extLst>
                    <a:ext uri="{9D8B030D-6E8A-4147-A177-3AD203B41FA5}">
                      <a16:colId xmlns:a16="http://schemas.microsoft.com/office/drawing/2014/main" val="568303345"/>
                    </a:ext>
                  </a:extLst>
                </a:gridCol>
                <a:gridCol w="712810">
                  <a:extLst>
                    <a:ext uri="{9D8B030D-6E8A-4147-A177-3AD203B41FA5}">
                      <a16:colId xmlns:a16="http://schemas.microsoft.com/office/drawing/2014/main" val="1919924687"/>
                    </a:ext>
                  </a:extLst>
                </a:gridCol>
                <a:gridCol w="712810">
                  <a:extLst>
                    <a:ext uri="{9D8B030D-6E8A-4147-A177-3AD203B41FA5}">
                      <a16:colId xmlns:a16="http://schemas.microsoft.com/office/drawing/2014/main" val="1992687684"/>
                    </a:ext>
                  </a:extLst>
                </a:gridCol>
                <a:gridCol w="712810">
                  <a:extLst>
                    <a:ext uri="{9D8B030D-6E8A-4147-A177-3AD203B41FA5}">
                      <a16:colId xmlns:a16="http://schemas.microsoft.com/office/drawing/2014/main" val="930193377"/>
                    </a:ext>
                  </a:extLst>
                </a:gridCol>
                <a:gridCol w="712810">
                  <a:extLst>
                    <a:ext uri="{9D8B030D-6E8A-4147-A177-3AD203B41FA5}">
                      <a16:colId xmlns:a16="http://schemas.microsoft.com/office/drawing/2014/main" val="1762271057"/>
                    </a:ext>
                  </a:extLst>
                </a:gridCol>
                <a:gridCol w="712810">
                  <a:extLst>
                    <a:ext uri="{9D8B030D-6E8A-4147-A177-3AD203B41FA5}">
                      <a16:colId xmlns:a16="http://schemas.microsoft.com/office/drawing/2014/main" val="3825475135"/>
                    </a:ext>
                  </a:extLst>
                </a:gridCol>
                <a:gridCol w="712810">
                  <a:extLst>
                    <a:ext uri="{9D8B030D-6E8A-4147-A177-3AD203B41FA5}">
                      <a16:colId xmlns:a16="http://schemas.microsoft.com/office/drawing/2014/main" val="805907793"/>
                    </a:ext>
                  </a:extLst>
                </a:gridCol>
              </a:tblGrid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Kosaka 200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5771186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tsumoto 201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8165764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IAID 2018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9509011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lffenaar 20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3212673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lffenaar 20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1741911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eer 2007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0715369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halodi 201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261293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oak 201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7751556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lackman 202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1028862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onte 200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6648759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slam 201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4128358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ee 200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2641428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uque 201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2167295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yrianthefs 2006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9881167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ea 20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8964688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woboda 20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7140879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raunmuller 20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5015719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ojutti 201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6980685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ojutti 201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0316066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ong 201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6532797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ng 202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5510943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Hiraki 20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1650078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uque 201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2374049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tsumoto 201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019359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rata 201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672195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ukui 201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3139949"/>
                  </a:ext>
                </a:extLst>
              </a:tr>
              <a:tr h="1573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suji 201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323486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F5BC9248-08DE-4150-D8C9-3015B8573AF7}"/>
              </a:ext>
            </a:extLst>
          </p:cNvPr>
          <p:cNvSpPr txBox="1"/>
          <p:nvPr/>
        </p:nvSpPr>
        <p:spPr>
          <a:xfrm rot="16200000">
            <a:off x="1364062" y="1177530"/>
            <a:ext cx="14670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founding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35A1177-5278-8053-4521-60930EF396CA}"/>
              </a:ext>
            </a:extLst>
          </p:cNvPr>
          <p:cNvSpPr txBox="1"/>
          <p:nvPr/>
        </p:nvSpPr>
        <p:spPr>
          <a:xfrm rot="16200000">
            <a:off x="2159233" y="1316991"/>
            <a:ext cx="11881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ection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67CD2C0-F274-8414-B8D0-32C2FF54C798}"/>
              </a:ext>
            </a:extLst>
          </p:cNvPr>
          <p:cNvSpPr txBox="1"/>
          <p:nvPr/>
        </p:nvSpPr>
        <p:spPr>
          <a:xfrm rot="16200000">
            <a:off x="2747031" y="1212796"/>
            <a:ext cx="13965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vention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21E4A96-9CC8-FBC6-CE2F-5B48BF6E7C58}"/>
              </a:ext>
            </a:extLst>
          </p:cNvPr>
          <p:cNvSpPr txBox="1"/>
          <p:nvPr/>
        </p:nvSpPr>
        <p:spPr>
          <a:xfrm rot="16200000">
            <a:off x="3089052" y="757171"/>
            <a:ext cx="209544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viation from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nded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vention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2652F42-DD5C-BB18-4E3C-65BEA9071142}"/>
              </a:ext>
            </a:extLst>
          </p:cNvPr>
          <p:cNvSpPr txBox="1"/>
          <p:nvPr/>
        </p:nvSpPr>
        <p:spPr>
          <a:xfrm rot="16200000">
            <a:off x="4130830" y="1188751"/>
            <a:ext cx="14446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ssing data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10B243B-00E8-7BD3-9B91-91F4BD435A7E}"/>
              </a:ext>
            </a:extLst>
          </p:cNvPr>
          <p:cNvSpPr txBox="1"/>
          <p:nvPr/>
        </p:nvSpPr>
        <p:spPr>
          <a:xfrm rot="16200000">
            <a:off x="4865582" y="1124311"/>
            <a:ext cx="13580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surement of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utcome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84FAB81-90C3-AF92-D6BA-5DA489ECE363}"/>
              </a:ext>
            </a:extLst>
          </p:cNvPr>
          <p:cNvSpPr txBox="1"/>
          <p:nvPr/>
        </p:nvSpPr>
        <p:spPr>
          <a:xfrm rot="16200000">
            <a:off x="5617165" y="1292145"/>
            <a:ext cx="1237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orting bia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表格 11">
            <a:extLst>
              <a:ext uri="{FF2B5EF4-FFF2-40B4-BE49-F238E27FC236}">
                <a16:creationId xmlns:a16="http://schemas.microsoft.com/office/drawing/2014/main" id="{BB35012D-D0E2-7312-02EC-96269A12EB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2296814"/>
              </p:ext>
            </p:extLst>
          </p:nvPr>
        </p:nvGraphicFramePr>
        <p:xfrm>
          <a:off x="1610041" y="7942122"/>
          <a:ext cx="641444" cy="1120141"/>
        </p:xfrm>
        <a:graphic>
          <a:graphicData uri="http://schemas.openxmlformats.org/drawingml/2006/table">
            <a:tbl>
              <a:tblPr/>
              <a:tblGrid>
                <a:gridCol w="641444">
                  <a:extLst>
                    <a:ext uri="{9D8B030D-6E8A-4147-A177-3AD203B41FA5}">
                      <a16:colId xmlns:a16="http://schemas.microsoft.com/office/drawing/2014/main" val="3110169190"/>
                    </a:ext>
                  </a:extLst>
                </a:gridCol>
              </a:tblGrid>
              <a:tr h="277674"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7389325"/>
                  </a:ext>
                </a:extLst>
              </a:tr>
              <a:tr h="287119"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2588837"/>
                  </a:ext>
                </a:extLst>
              </a:tr>
              <a:tr h="277674"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6588592"/>
                  </a:ext>
                </a:extLst>
              </a:tr>
              <a:tr h="277674"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2972199"/>
                  </a:ext>
                </a:extLst>
              </a:tr>
            </a:tbl>
          </a:graphicData>
        </a:graphic>
      </p:graphicFrame>
      <p:sp>
        <p:nvSpPr>
          <p:cNvPr id="14" name="文本框 13">
            <a:extLst>
              <a:ext uri="{FF2B5EF4-FFF2-40B4-BE49-F238E27FC236}">
                <a16:creationId xmlns:a16="http://schemas.microsoft.com/office/drawing/2014/main" id="{C6B38D3D-0561-AAEE-9EC2-F9EDE6D548D0}"/>
              </a:ext>
            </a:extLst>
          </p:cNvPr>
          <p:cNvSpPr txBox="1"/>
          <p:nvPr/>
        </p:nvSpPr>
        <p:spPr>
          <a:xfrm>
            <a:off x="2251485" y="7879363"/>
            <a:ext cx="1626965" cy="1192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200"/>
              </a:lnSpc>
            </a:pP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</a:p>
          <a:p>
            <a:pPr>
              <a:lnSpc>
                <a:spcPts val="2200"/>
              </a:lnSpc>
            </a:pP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rate</a:t>
            </a:r>
          </a:p>
          <a:p>
            <a:pPr>
              <a:lnSpc>
                <a:spcPts val="2200"/>
              </a:lnSpc>
            </a:pP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</a:p>
          <a:p>
            <a:pPr>
              <a:lnSpc>
                <a:spcPts val="2200"/>
              </a:lnSpc>
            </a:pP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informatio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1452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8</TotalTime>
  <Words>190</Words>
  <Application>Microsoft Office PowerPoint</Application>
  <PresentationFormat>全屏显示(4:3)</PresentationFormat>
  <Paragraphs>84</Paragraphs>
  <Slides>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U XIAOXI</dc:creator>
  <cp:lastModifiedBy>劉 小茜</cp:lastModifiedBy>
  <cp:revision>62</cp:revision>
  <dcterms:created xsi:type="dcterms:W3CDTF">2020-07-25T07:52:23Z</dcterms:created>
  <dcterms:modified xsi:type="dcterms:W3CDTF">2022-10-19T02:07:45Z</dcterms:modified>
</cp:coreProperties>
</file>